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6" r:id="rId3"/>
  </p:sldIdLst>
  <p:sldSz cx="8999855" cy="14399895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4" userDrawn="1">
          <p15:clr>
            <a:srgbClr val="A4A3A4"/>
          </p15:clr>
        </p15:guide>
        <p15:guide id="2" pos="28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78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90" y="96"/>
      </p:cViewPr>
      <p:guideLst>
        <p:guide orient="horz" pos="4534"/>
        <p:guide pos="2834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73325" y="1279525"/>
            <a:ext cx="21590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125177" y="2778585"/>
            <a:ext cx="6751062" cy="4593304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5905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125177" y="7565272"/>
            <a:ext cx="6751062" cy="3477556"/>
          </a:xfrm>
        </p:spPr>
        <p:txBody>
          <a:bodyPr>
            <a:normAutofit/>
          </a:bodyPr>
          <a:lstStyle>
            <a:lvl1pPr marL="0" indent="0" algn="ctr">
              <a:buNone/>
              <a:defRPr sz="1775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450215" indent="0" algn="ctr">
              <a:buNone/>
              <a:defRPr sz="1970"/>
            </a:lvl2pPr>
            <a:lvl3pPr marL="900430" indent="0" algn="ctr">
              <a:buNone/>
              <a:defRPr sz="1775"/>
            </a:lvl3pPr>
            <a:lvl4pPr marL="1350010" indent="0" algn="ctr">
              <a:buNone/>
              <a:defRPr sz="1570"/>
            </a:lvl4pPr>
            <a:lvl5pPr marL="1799590" indent="0" algn="ctr">
              <a:buNone/>
              <a:defRPr sz="1570"/>
            </a:lvl5pPr>
            <a:lvl6pPr marL="2250440" indent="0" algn="ctr">
              <a:buNone/>
              <a:defRPr sz="1570"/>
            </a:lvl6pPr>
            <a:lvl7pPr marL="2700020" indent="0" algn="ctr">
              <a:buNone/>
              <a:defRPr sz="1570"/>
            </a:lvl7pPr>
            <a:lvl8pPr marL="3150235" indent="0" algn="ctr">
              <a:buNone/>
              <a:defRPr sz="1570"/>
            </a:lvl8pPr>
            <a:lvl9pPr marL="3600450" indent="0" algn="ctr">
              <a:buNone/>
              <a:defRPr sz="157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618847" y="1158392"/>
            <a:ext cx="7763721" cy="1167537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8200" y="542806"/>
            <a:ext cx="7763721" cy="2784047"/>
          </a:xfrm>
        </p:spPr>
        <p:txBody>
          <a:bodyPr anchor="ctr" anchorCtr="0">
            <a:normAutofit/>
          </a:bodyPr>
          <a:lstStyle>
            <a:lvl1pPr>
              <a:defRPr sz="2365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8200" y="3834315"/>
            <a:ext cx="7763721" cy="9139008"/>
          </a:xfrm>
        </p:spPr>
        <p:txBody>
          <a:bodyPr>
            <a:normAutofit/>
          </a:bodyPr>
          <a:lstStyle>
            <a:lvl1pPr>
              <a:defRPr sz="197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775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4159" y="7878379"/>
            <a:ext cx="5405538" cy="1704073"/>
          </a:xfrm>
        </p:spPr>
        <p:txBody>
          <a:bodyPr anchor="b">
            <a:normAutofit/>
          </a:bodyPr>
          <a:lstStyle>
            <a:lvl1pPr>
              <a:defRPr sz="394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4159" y="9682329"/>
            <a:ext cx="5405538" cy="1360044"/>
          </a:xfrm>
        </p:spPr>
        <p:txBody>
          <a:bodyPr>
            <a:normAutofit/>
          </a:bodyPr>
          <a:lstStyle>
            <a:lvl1pPr marL="0" indent="0">
              <a:buNone/>
              <a:defRPr sz="1775">
                <a:solidFill>
                  <a:schemeClr val="tx1"/>
                </a:solidFill>
              </a:defRPr>
            </a:lvl1pPr>
            <a:lvl2pPr marL="450215" indent="0">
              <a:buNone/>
              <a:defRPr sz="1970">
                <a:solidFill>
                  <a:schemeClr val="tx1">
                    <a:tint val="75000"/>
                  </a:schemeClr>
                </a:solidFill>
              </a:defRPr>
            </a:lvl2pPr>
            <a:lvl3pPr marL="900430" indent="0">
              <a:buNone/>
              <a:defRPr sz="1775">
                <a:solidFill>
                  <a:schemeClr val="tx1">
                    <a:tint val="75000"/>
                  </a:schemeClr>
                </a:solidFill>
              </a:defRPr>
            </a:lvl3pPr>
            <a:lvl4pPr marL="1350010" indent="0">
              <a:buNone/>
              <a:defRPr sz="1570">
                <a:solidFill>
                  <a:schemeClr val="tx1">
                    <a:tint val="75000"/>
                  </a:schemeClr>
                </a:solidFill>
              </a:defRPr>
            </a:lvl4pPr>
            <a:lvl5pPr marL="1799590" indent="0">
              <a:buNone/>
              <a:defRPr sz="1570">
                <a:solidFill>
                  <a:schemeClr val="tx1">
                    <a:tint val="75000"/>
                  </a:schemeClr>
                </a:solidFill>
              </a:defRPr>
            </a:lvl5pPr>
            <a:lvl6pPr marL="2250440" indent="0">
              <a:buNone/>
              <a:defRPr sz="1570">
                <a:solidFill>
                  <a:schemeClr val="tx1">
                    <a:tint val="75000"/>
                  </a:schemeClr>
                </a:solidFill>
              </a:defRPr>
            </a:lvl6pPr>
            <a:lvl7pPr marL="2700020" indent="0">
              <a:buNone/>
              <a:defRPr sz="1570">
                <a:solidFill>
                  <a:schemeClr val="tx1">
                    <a:tint val="75000"/>
                  </a:schemeClr>
                </a:solidFill>
              </a:defRPr>
            </a:lvl7pPr>
            <a:lvl8pPr marL="3150235" indent="0">
              <a:buNone/>
              <a:defRPr sz="1570">
                <a:solidFill>
                  <a:schemeClr val="tx1">
                    <a:tint val="75000"/>
                  </a:schemeClr>
                </a:solidFill>
              </a:defRPr>
            </a:lvl8pPr>
            <a:lvl9pPr marL="3600450" indent="0">
              <a:buNone/>
              <a:defRPr sz="15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8200" y="542806"/>
            <a:ext cx="7763721" cy="2784047"/>
          </a:xfrm>
        </p:spPr>
        <p:txBody>
          <a:bodyPr>
            <a:normAutofit/>
          </a:bodyPr>
          <a:lstStyle>
            <a:lvl1pPr>
              <a:defRPr sz="2365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8200" y="3834315"/>
            <a:ext cx="3825602" cy="913900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197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775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416320" y="3834315"/>
            <a:ext cx="3825602" cy="913900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197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775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57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0020" y="766863"/>
            <a:ext cx="7763721" cy="278404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0020" y="3664899"/>
            <a:ext cx="3808020" cy="1730442"/>
          </a:xfrm>
        </p:spPr>
        <p:txBody>
          <a:bodyPr anchor="b"/>
          <a:lstStyle>
            <a:lvl1pPr marL="0" indent="0">
              <a:buNone/>
              <a:defRPr sz="2365" b="1"/>
            </a:lvl1pPr>
            <a:lvl2pPr marL="450215" indent="0">
              <a:buNone/>
              <a:defRPr sz="1970" b="1"/>
            </a:lvl2pPr>
            <a:lvl3pPr marL="900430" indent="0">
              <a:buNone/>
              <a:defRPr sz="1775" b="1"/>
            </a:lvl3pPr>
            <a:lvl4pPr marL="1350010" indent="0">
              <a:buNone/>
              <a:defRPr sz="1570" b="1"/>
            </a:lvl4pPr>
            <a:lvl5pPr marL="1799590" indent="0">
              <a:buNone/>
              <a:defRPr sz="1570" b="1"/>
            </a:lvl5pPr>
            <a:lvl6pPr marL="2250440" indent="0">
              <a:buNone/>
              <a:defRPr sz="1570" b="1"/>
            </a:lvl6pPr>
            <a:lvl7pPr marL="2700020" indent="0">
              <a:buNone/>
              <a:defRPr sz="1570" b="1"/>
            </a:lvl7pPr>
            <a:lvl8pPr marL="3150235" indent="0">
              <a:buNone/>
              <a:defRPr sz="1570" b="1"/>
            </a:lvl8pPr>
            <a:lvl9pPr marL="3600450" indent="0">
              <a:buNone/>
              <a:defRPr sz="157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0020" y="5493499"/>
            <a:ext cx="3808020" cy="7506498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556967" y="3664899"/>
            <a:ext cx="3826774" cy="1730442"/>
          </a:xfrm>
        </p:spPr>
        <p:txBody>
          <a:bodyPr anchor="b"/>
          <a:lstStyle>
            <a:lvl1pPr marL="0" indent="0">
              <a:buNone/>
              <a:defRPr sz="2365" b="1"/>
            </a:lvl1pPr>
            <a:lvl2pPr marL="450215" indent="0">
              <a:buNone/>
              <a:defRPr sz="1970" b="1"/>
            </a:lvl2pPr>
            <a:lvl3pPr marL="900430" indent="0">
              <a:buNone/>
              <a:defRPr sz="1775" b="1"/>
            </a:lvl3pPr>
            <a:lvl4pPr marL="1350010" indent="0">
              <a:buNone/>
              <a:defRPr sz="1570" b="1"/>
            </a:lvl4pPr>
            <a:lvl5pPr marL="1799590" indent="0">
              <a:buNone/>
              <a:defRPr sz="1570" b="1"/>
            </a:lvl5pPr>
            <a:lvl6pPr marL="2250440" indent="0">
              <a:buNone/>
              <a:defRPr sz="1570" b="1"/>
            </a:lvl6pPr>
            <a:lvl7pPr marL="2700020" indent="0">
              <a:buNone/>
              <a:defRPr sz="1570" b="1"/>
            </a:lvl7pPr>
            <a:lvl8pPr marL="3150235" indent="0">
              <a:buNone/>
              <a:defRPr sz="1570" b="1"/>
            </a:lvl8pPr>
            <a:lvl9pPr marL="3600450" indent="0">
              <a:buNone/>
              <a:defRPr sz="157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556967" y="5493499"/>
            <a:ext cx="3826774" cy="7506498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8847" y="5809822"/>
            <a:ext cx="7763721" cy="2784047"/>
          </a:xfrm>
        </p:spPr>
        <p:txBody>
          <a:bodyPr>
            <a:normAutofit/>
          </a:bodyPr>
          <a:lstStyle>
            <a:lvl1pPr algn="ctr">
              <a:defRPr sz="4720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477497" y="266735"/>
            <a:ext cx="3075188" cy="3360861"/>
          </a:xfrm>
        </p:spPr>
        <p:txBody>
          <a:bodyPr anchor="ctr" anchorCtr="0">
            <a:normAutofit/>
          </a:bodyPr>
          <a:lstStyle>
            <a:lvl1pPr>
              <a:defRPr sz="2365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3827374" y="1609554"/>
            <a:ext cx="4294998" cy="10699740"/>
          </a:xfrm>
        </p:spPr>
        <p:txBody>
          <a:bodyPr/>
          <a:lstStyle>
            <a:lvl1pPr marL="0" indent="0">
              <a:buNone/>
              <a:defRPr sz="3150"/>
            </a:lvl1pPr>
            <a:lvl2pPr marL="450215" indent="0">
              <a:buNone/>
              <a:defRPr sz="2755"/>
            </a:lvl2pPr>
            <a:lvl3pPr marL="900430" indent="0">
              <a:buNone/>
              <a:defRPr sz="2365"/>
            </a:lvl3pPr>
            <a:lvl4pPr marL="1350010" indent="0">
              <a:buNone/>
              <a:defRPr sz="1970"/>
            </a:lvl4pPr>
            <a:lvl5pPr marL="1799590" indent="0">
              <a:buNone/>
              <a:defRPr sz="1970"/>
            </a:lvl5pPr>
            <a:lvl6pPr marL="2250440" indent="0">
              <a:buNone/>
              <a:defRPr sz="1970"/>
            </a:lvl6pPr>
            <a:lvl7pPr marL="2700020" indent="0">
              <a:buNone/>
              <a:defRPr sz="1970"/>
            </a:lvl7pPr>
            <a:lvl8pPr marL="3150235" indent="0">
              <a:buNone/>
              <a:defRPr sz="1970"/>
            </a:lvl8pPr>
            <a:lvl9pPr marL="3600450" indent="0">
              <a:buNone/>
              <a:defRPr sz="197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81247" y="4321107"/>
            <a:ext cx="3075188" cy="8005385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570"/>
            </a:lvl1pPr>
            <a:lvl2pPr marL="450215" indent="0">
              <a:buNone/>
              <a:defRPr sz="1375"/>
            </a:lvl2pPr>
            <a:lvl3pPr marL="900430" indent="0">
              <a:buNone/>
              <a:defRPr sz="1180"/>
            </a:lvl3pPr>
            <a:lvl4pPr marL="1350010" indent="0">
              <a:buNone/>
              <a:defRPr sz="985"/>
            </a:lvl4pPr>
            <a:lvl5pPr marL="1799590" indent="0">
              <a:buNone/>
              <a:defRPr sz="985"/>
            </a:lvl5pPr>
            <a:lvl6pPr marL="2250440" indent="0">
              <a:buNone/>
              <a:defRPr sz="985"/>
            </a:lvl6pPr>
            <a:lvl7pPr marL="2700020" indent="0">
              <a:buNone/>
              <a:defRPr sz="985"/>
            </a:lvl7pPr>
            <a:lvl8pPr marL="3150235" indent="0">
              <a:buNone/>
              <a:defRPr sz="985"/>
            </a:lvl8pPr>
            <a:lvl9pPr marL="3600450" indent="0">
              <a:buNone/>
              <a:defRPr sz="985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253466" y="766863"/>
            <a:ext cx="1129102" cy="12206461"/>
          </a:xfrm>
        </p:spPr>
        <p:txBody>
          <a:bodyPr vert="eaVert">
            <a:normAutofit/>
          </a:bodyPr>
          <a:lstStyle>
            <a:lvl1pPr>
              <a:defRPr sz="354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18847" y="766863"/>
            <a:ext cx="6556118" cy="12206461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18847" y="766863"/>
            <a:ext cx="7763721" cy="278404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8847" y="3834315"/>
            <a:ext cx="7763721" cy="91390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18847" y="13350086"/>
            <a:ext cx="2025318" cy="7668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1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981719" y="13350086"/>
            <a:ext cx="3037978" cy="7668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1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357250" y="13350086"/>
            <a:ext cx="2025318" cy="7668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1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00430" rtl="0" eaLnBrk="1" latinLnBrk="0" hangingPunct="1">
        <a:lnSpc>
          <a:spcPct val="90000"/>
        </a:lnSpc>
        <a:spcBef>
          <a:spcPct val="0"/>
        </a:spcBef>
        <a:buNone/>
        <a:defRPr sz="39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5425" indent="-225425" algn="l" defTabSz="900430" rtl="0" eaLnBrk="1" latinLnBrk="0" hangingPunct="1">
        <a:lnSpc>
          <a:spcPct val="90000"/>
        </a:lnSpc>
        <a:spcBef>
          <a:spcPct val="197000"/>
        </a:spcBef>
        <a:buFont typeface="Arial" panose="020B0604020202020204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1pPr>
      <a:lvl2pPr marL="675005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970" kern="1200">
          <a:solidFill>
            <a:schemeClr val="tx1"/>
          </a:solidFill>
          <a:latin typeface="+mn-lt"/>
          <a:ea typeface="+mn-ea"/>
          <a:cs typeface="+mn-cs"/>
        </a:defRPr>
      </a:lvl2pPr>
      <a:lvl3pPr marL="1125220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775" kern="1200">
          <a:solidFill>
            <a:schemeClr val="tx1"/>
          </a:solidFill>
          <a:latin typeface="+mn-lt"/>
          <a:ea typeface="+mn-ea"/>
          <a:cs typeface="+mn-cs"/>
        </a:defRPr>
      </a:lvl3pPr>
      <a:lvl4pPr marL="1575435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775" kern="1200">
          <a:solidFill>
            <a:schemeClr val="tx1"/>
          </a:solidFill>
          <a:latin typeface="+mn-lt"/>
          <a:ea typeface="+mn-ea"/>
          <a:cs typeface="+mn-cs"/>
        </a:defRPr>
      </a:lvl4pPr>
      <a:lvl5pPr marL="2025015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775" kern="1200">
          <a:solidFill>
            <a:schemeClr val="tx1"/>
          </a:solidFill>
          <a:latin typeface="+mn-lt"/>
          <a:ea typeface="+mn-ea"/>
          <a:cs typeface="+mn-cs"/>
        </a:defRPr>
      </a:lvl5pPr>
      <a:lvl6pPr marL="2475865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775" kern="1200">
          <a:solidFill>
            <a:schemeClr val="tx1"/>
          </a:solidFill>
          <a:latin typeface="+mn-lt"/>
          <a:ea typeface="+mn-ea"/>
          <a:cs typeface="+mn-cs"/>
        </a:defRPr>
      </a:lvl6pPr>
      <a:lvl7pPr marL="2925445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775" kern="1200">
          <a:solidFill>
            <a:schemeClr val="tx1"/>
          </a:solidFill>
          <a:latin typeface="+mn-lt"/>
          <a:ea typeface="+mn-ea"/>
          <a:cs typeface="+mn-cs"/>
        </a:defRPr>
      </a:lvl7pPr>
      <a:lvl8pPr marL="3375025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775" kern="1200">
          <a:solidFill>
            <a:schemeClr val="tx1"/>
          </a:solidFill>
          <a:latin typeface="+mn-lt"/>
          <a:ea typeface="+mn-ea"/>
          <a:cs typeface="+mn-cs"/>
        </a:defRPr>
      </a:lvl8pPr>
      <a:lvl9pPr marL="3824605" indent="-225425" algn="l" defTabSz="900430" rtl="0" eaLnBrk="1" latinLnBrk="0" hangingPunct="1">
        <a:lnSpc>
          <a:spcPct val="90000"/>
        </a:lnSpc>
        <a:spcBef>
          <a:spcPts val="490"/>
        </a:spcBef>
        <a:buFont typeface="Arial" panose="020B0604020202020204" pitchFamily="34" charset="0"/>
        <a:buChar char="•"/>
        <a:defRPr sz="17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1pPr>
      <a:lvl2pPr marL="450215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2pPr>
      <a:lvl3pPr marL="900430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3pPr>
      <a:lvl4pPr marL="1350010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4pPr>
      <a:lvl5pPr marL="1799590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5pPr>
      <a:lvl6pPr marL="2250440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6pPr>
      <a:lvl7pPr marL="2700020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7pPr>
      <a:lvl8pPr marL="3150235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8pPr>
      <a:lvl9pPr marL="3600450" algn="l" defTabSz="900430" rtl="0" eaLnBrk="1" latinLnBrk="0" hangingPunct="1">
        <a:defRPr sz="177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2" name="表格 1"/>
          <p:cNvGraphicFramePr/>
          <p:nvPr>
            <p:custDataLst>
              <p:tags r:id="rId1"/>
            </p:custDataLst>
          </p:nvPr>
        </p:nvGraphicFramePr>
        <p:xfrm>
          <a:off x="226695" y="534035"/>
          <a:ext cx="8546465" cy="12144375"/>
        </p:xfrm>
        <a:graphic>
          <a:graphicData uri="http://schemas.openxmlformats.org/drawingml/2006/table">
            <a:tbl>
              <a:tblPr/>
              <a:tblGrid>
                <a:gridCol w="3493135"/>
                <a:gridCol w="2311400"/>
                <a:gridCol w="2311400"/>
                <a:gridCol w="430530"/>
              </a:tblGrid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Variable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ingle (n=19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SPO (n=19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ALP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0.00 (53.00, 113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8.50 (57.75, 122.7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58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4.00 (54.00, 113.2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9.00 (55.88, 106.2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81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5.50 (62.00, 123.2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4.00 (62.75, 117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968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16.00 (77.75, 191.9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14.75 (79.33, 203.2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984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T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5.80 (14.20, 17.7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5.55 (14.00, 18.3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779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4.15 (13.20, 15.6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4.00 (13.00, 15.4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1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30 (12.50, 14.5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25 (12.57, 14.6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767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2.20 (11.50, 12.8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2.20 (11.70, 13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509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TBIL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6.10 (22.25-60.7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8.40 (25.00-57.2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23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2.30 (14.47-34.08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4.30 (15.75-38.33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268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9.60 (14.10-33.1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1.20 (14.90-36.23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72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25 (9.74-19.3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3.55 (9.73-20.1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36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INR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37 (1.23, 1.57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36 (1.23, 1.61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846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23 (1.13, 1.3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24 (1.14, 1.37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38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15 (1.08, 1.26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15 (1.09, 1.29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64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06 (0.99, 1.1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.06 (1.00, 1.14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08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AST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39.30 (227.95, 684.98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91.15 (181.25, 547.4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042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14.90 (62.50, 213.07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7.35 (53.35, 159.88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022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1.90 (28.60, 61.9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0.35 (26.03, 63.7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16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1.00 (19.85, 41.58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0.40 (20.85, 38.98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839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ALT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63.85 (165.22, 535.9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250.00 (137.88, 458.4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229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77.75 (98.55, 325.07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46.35 (82.80, 269.0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040 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8.90 (57.17, 183.18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1.65 (48.40, 138.88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048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1.50 (18.85, 48.5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1.05 (19.65, 43.7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944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CHE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468.50 (3729.25, 5499.5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4595.50 (3629.75, 5885.7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372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475.50 (2906.75, 4427.7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676.50 (2885.00, 4585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256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459.00 (2891.50, 4372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3620.50 (2828.75, 4673.5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34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484.00 (5308.75, 7518.7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6610.50 (5309.00, 8069.2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262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WBC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.96 (8.19, 15.06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.79 (8.12, 14.29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59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.16 (6.86, 11.34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.93 (6.79, 11.89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828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30 (5.68, 10.14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.46 (5.46, 10.39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922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96 (4.53, 8.0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5.83 (4.68, 8.54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847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HGB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2.50 (93.00, 123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11.50 (94.00, 128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306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9.00 (80.00, 103.2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2.00 (81.00, 106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2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4.00 (86.00, 107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95.00 (86.00, 106.2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64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24.50 (116.00, 133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23.00 (110.75, 136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71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l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BNP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b"/>
                      <a:endParaRPr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b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1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29.45 (75.50, 255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9.50 (73.97, 252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49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3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68.00 (67.45, 349.5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06.50 (48.83, 311.85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129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OD 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122.55 (32.58, 288.02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72.77 (15.30, 215.0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035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8125"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Pre-operation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7.35 (71.40, 101.3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82.65 (69.10, 95.70)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p>
                      <a:pPr marL="9525" indent="0" algn="ctr" fontAlgn="ctr"/>
                      <a:r>
                        <a:rPr lang="en-US" altLang="zh-CN" sz="1200" b="0" i="0">
                          <a:solidFill>
                            <a:srgbClr val="000000"/>
                          </a:solidFill>
                          <a:latin typeface="Times New Roman" panose="02020603050405020304"/>
                          <a:ea typeface="Times New Roman" panose="02020603050405020304"/>
                        </a:rPr>
                        <a:t>0.027</a:t>
                      </a:r>
                      <a:endParaRPr lang="en-US" altLang="zh-CN" sz="1200" b="0" i="0">
                        <a:solidFill>
                          <a:srgbClr val="000000"/>
                        </a:solidFill>
                        <a:latin typeface="Times New Roman" panose="02020603050405020304"/>
                        <a:ea typeface="Times New Roman" panose="02020603050405020304"/>
                      </a:endParaRPr>
                    </a:p>
                  </a:txBody>
                  <a:tcPr marL="9842" marR="9842" marT="9842" anchor="ctr" anchorCtr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331470" y="13024485"/>
            <a:ext cx="83362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l  table 1</a:t>
            </a:r>
            <a:r>
              <a:rPr lang="en-US" altLang="zh-CN">
                <a:latin typeface="Times New Roman" panose="02020603050405020304" charset="0"/>
                <a:cs typeface="Times New Roman" panose="02020603050405020304" charset="0"/>
                <a:sym typeface="+mn-ea"/>
              </a:rPr>
              <a:t> Comparison of laboratory tests between different types of occlusions after 1:1 propensity score matching.</a:t>
            </a:r>
            <a:endParaRPr lang="en-US" altLang="zh-CN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TABLE_ENDDRAG_ORIGIN_RECT" val="672*898"/>
  <p:tag name="TABLE_ENDDRAG_RECT" val="13*4*672*898"/>
</p:tagLst>
</file>

<file path=ppt/theme/theme1.xml><?xml version="1.0" encoding="utf-8"?>
<a:theme xmlns:a="http://schemas.openxmlformats.org/drawingml/2006/main" name="WPS​​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Arial Black-Arial">
      <a:majorFont>
        <a:latin typeface="Arial Black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微软雅黑"/>
        <a:ea typeface=""/>
        <a:cs typeface=""/>
        <a:font script="Jpan" typeface="游ゴシック Light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微软雅黑"/>
        <a:ea typeface=""/>
        <a:cs typeface=""/>
        <a:font script="Jpan" typeface="游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26</Words>
  <Application>WPS 演示</Application>
  <PresentationFormat>宽屏</PresentationFormat>
  <Paragraphs>3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Times New Roman</vt:lpstr>
      <vt:lpstr>微软雅黑</vt:lpstr>
      <vt:lpstr>Arial Unicode MS</vt:lpstr>
      <vt:lpstr>Arial Black</vt:lpstr>
      <vt:lpstr>黑体</vt:lpstr>
      <vt:lpstr>Calibri</vt:lpstr>
      <vt:lpstr>WPS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Administrator</cp:lastModifiedBy>
  <cp:revision>6</cp:revision>
  <dcterms:created xsi:type="dcterms:W3CDTF">2023-07-11T07:43:00Z</dcterms:created>
  <dcterms:modified xsi:type="dcterms:W3CDTF">2025-07-29T13:07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8.2.17149</vt:lpwstr>
  </property>
  <property fmtid="{D5CDD505-2E9C-101B-9397-08002B2CF9AE}" pid="3" name="ICV">
    <vt:lpwstr>13993626897F91E90608AD645D25FD23_42</vt:lpwstr>
  </property>
</Properties>
</file>